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2" r:id="rId3"/>
  </p:sldIdLst>
  <p:sldSz cx="6480175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24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0E08F-41F2-4483-B6D7-7E7C8A60A9ED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71675" y="1143000"/>
            <a:ext cx="2914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F98271-0DF4-46E0-9056-F19C80B238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38581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E324FF-B98F-491E-98FE-1962668B48D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47691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E324FF-B98F-491E-98FE-1962668B48D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1031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EE9764-AA81-4D23-9FD7-5D8AF9904F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10022" y="1122363"/>
            <a:ext cx="486013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4D88256-47E3-4126-AAF6-1AB07FAB1C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10022" y="3602038"/>
            <a:ext cx="486013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4AF869-A301-4C32-A1FD-7AF60AB0B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02037D-6EC1-4712-A245-4E1F4B5EC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678084-707D-40C4-9EA5-8356ADF40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9174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E5FB14-5B25-4D4E-8357-74C462130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DEF2113-C521-4006-BE2C-C8BE35EDD4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B10157-134F-4C0E-ACB4-BFF4EF471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6E5850-DB24-4708-B2B0-63FCD5E8B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9B73B4-288F-4380-B759-6B2BF2093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1378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0A16F0E-5E04-4DF3-B692-F90F7E7B32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637375" y="365125"/>
            <a:ext cx="1397288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A47FA2-1F49-4488-B8B2-81D305214A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45512" y="365125"/>
            <a:ext cx="4110861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C12E2F-61C2-4607-8AAF-0C0E859E4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E34017-D0C2-45A6-97F4-C426FA234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43F13C-FA6D-4E2E-B560-6ED6A1918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4770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2F7721-324F-4C66-96C2-4B58C098FD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CE29A6C-F7CB-476F-B79D-3FBB061E71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A8C60D-4C4E-4B3B-A9EF-68B0FD48D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DD289A2-15BE-499A-961F-7186448D6C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2039D1-B0E4-4FA4-B521-09C4D1936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5161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4AC353-C088-4AC7-AC13-20EFA15CC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2137" y="1709739"/>
            <a:ext cx="558915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DA8E83-47C5-4F62-8277-1D8C42939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2137" y="4589464"/>
            <a:ext cx="558915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F2765B-325F-44FF-BBCC-631107EA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AC4361-21E2-4EC4-A70A-5BE918AD0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51F0A5-0739-47DF-8E9C-4C256E0DB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159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DC55E6-24A6-4859-8AC1-2E4E114EC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64A90A-A407-41FE-9FEF-80964A596A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45512" y="1825625"/>
            <a:ext cx="27540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19A135-3FE0-4F59-99D1-D702CC114A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280589" y="1825625"/>
            <a:ext cx="27540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42C510-486A-4C4C-82B0-6C57DF909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04E073-B737-4071-B396-25F143DA6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91C8663-63AE-4A5D-904A-80A3B3A7C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209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EC8C2C-E08E-442C-BB79-C1ED38E56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365126"/>
            <a:ext cx="5589151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4DA7FF-CEA1-414D-ADF6-FC3CF025B6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6356" y="1681163"/>
            <a:ext cx="274141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B11DAE5-59D2-44A5-AC79-37D16F5ACA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46356" y="2505075"/>
            <a:ext cx="274141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F544DE4-E217-4A67-8EAD-7E61B00FB1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280589" y="1681163"/>
            <a:ext cx="275491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80A2200-9C72-41D2-9211-AB762EE8E2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280589" y="2505075"/>
            <a:ext cx="275491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186429F-6F39-498F-B420-CDDF26291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74A35E8-7A99-4EA4-9E64-E738AC4D1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AA943D2-F343-4603-86C5-B9A7B3A87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154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63ADD8-49D6-419A-991E-3B652FE384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E868A43-D51C-4D9D-8B1E-1D06B15C8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892D488-AEA2-4504-827B-B9907D866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E470B29-5982-44B6-A808-620D7FFD7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447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232078F-21FD-47F6-95B3-BBDEFCB9A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53F6EA6-BA05-4622-B8E7-7E99677EB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4F6DEAB-1B4A-4B6C-A109-9FE7CA6A6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3034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51D33E-E773-4AA0-8623-6086A7A8C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70DA285-52B5-433D-B9D9-1C40F4B6AA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754918" y="987426"/>
            <a:ext cx="3280589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72EDCCA-0150-48CC-8CE3-E968CB894D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6F59AC-9955-494D-9DC3-9191C6444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1EE972-B8F3-471E-84B0-834781360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1B3F90-D779-427D-9249-A186AD4CD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546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CEBDA6-07B6-4183-80A2-E56B300B1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8E2225F-46D1-452C-93B3-E636DD7529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754918" y="987426"/>
            <a:ext cx="328058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AD69D99-40E7-408F-9758-B7567E8A8A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AFDC7B-F76B-4A94-8F1D-5FC461B50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FBF3DB-8C61-48AC-BBF4-87048D683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DB5FE9-A2E6-467C-A8CD-FA082A83E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038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710FA0-C686-4D54-897B-6E1227554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5512" y="365126"/>
            <a:ext cx="558915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3B96DB-45F3-4143-9B6D-1D3DA8D0A3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45512" y="1825625"/>
            <a:ext cx="558915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04B4F0-1B02-4FB5-88D0-90BF29E734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45512" y="6356351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3A691-3D84-42EF-AB3F-9C5266B6A345}" type="datetimeFigureOut">
              <a:rPr lang="zh-CN" altLang="en-US" smtClean="0"/>
              <a:t>2023-10-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7E1B2F-79D9-4726-8C19-919BFEDE74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146558" y="6356351"/>
            <a:ext cx="2187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D4FE27-27E6-45F5-AC42-BC9EB96BA6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576624" y="6356351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51912-6711-4282-9622-9C37AB76F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833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2.png"/><Relationship Id="rId10" Type="http://schemas.openxmlformats.org/officeDocument/2006/relationships/image" Target="../media/image5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7.png"/><Relationship Id="rId7" Type="http://schemas.microsoft.com/office/2007/relationships/hdphoto" Target="../media/hdphoto6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2.png"/><Relationship Id="rId4" Type="http://schemas.openxmlformats.org/officeDocument/2006/relationships/image" Target="../media/image8.png"/><Relationship Id="rId9" Type="http://schemas.microsoft.com/office/2007/relationships/hdphoto" Target="../media/hdphoto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D8E9A02-DE78-47AB-9121-7982780ABF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67617" y="688568"/>
            <a:ext cx="2305093" cy="1903644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85855EA-2B1F-4D8D-953F-4B97B896F8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300" y="701073"/>
            <a:ext cx="2257810" cy="190364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4197639-600E-4E0C-90D2-38533474EC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67617" y="2761895"/>
            <a:ext cx="2618404" cy="181527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1ECFB24-344F-4FEF-A1CE-A9EFC983330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71300" y="2774400"/>
            <a:ext cx="2257810" cy="181527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7ADFBF7-1925-4F6C-A11D-8ABA5BA1CC3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67617" y="4746857"/>
            <a:ext cx="2071649" cy="180100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928E5BC-88B2-45F9-A01B-562B26CE7BD3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 l="7914" t="7914" r="7914" b="7914"/>
          <a:stretch/>
        </p:blipFill>
        <p:spPr>
          <a:xfrm>
            <a:off x="571300" y="4759362"/>
            <a:ext cx="2257810" cy="143097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B5494A6F-7F80-4A4F-B02D-3E30F1CE53E1}"/>
              </a:ext>
            </a:extLst>
          </p:cNvPr>
          <p:cNvSpPr/>
          <p:nvPr/>
        </p:nvSpPr>
        <p:spPr>
          <a:xfrm>
            <a:off x="1278717" y="1578930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CEC0CFC0-2961-4122-96E6-F01CAF56CDAE}"/>
              </a:ext>
            </a:extLst>
          </p:cNvPr>
          <p:cNvSpPr/>
          <p:nvPr/>
        </p:nvSpPr>
        <p:spPr>
          <a:xfrm>
            <a:off x="1327422" y="3512996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F700E537-E8AE-4B79-99CF-31D61769CDD7}"/>
              </a:ext>
            </a:extLst>
          </p:cNvPr>
          <p:cNvSpPr/>
          <p:nvPr/>
        </p:nvSpPr>
        <p:spPr>
          <a:xfrm>
            <a:off x="1272432" y="5135977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100B66F-2C3F-4331-AE2C-2917CEBC16D9}"/>
              </a:ext>
            </a:extLst>
          </p:cNvPr>
          <p:cNvSpPr/>
          <p:nvPr/>
        </p:nvSpPr>
        <p:spPr>
          <a:xfrm>
            <a:off x="4262299" y="1288334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C42D6D3A-D5A9-41C6-B31A-E6946F6F62B2}"/>
              </a:ext>
            </a:extLst>
          </p:cNvPr>
          <p:cNvSpPr/>
          <p:nvPr/>
        </p:nvSpPr>
        <p:spPr>
          <a:xfrm>
            <a:off x="4169603" y="3448643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879EA686-CA37-49D1-8145-3FA8F6D88593}"/>
              </a:ext>
            </a:extLst>
          </p:cNvPr>
          <p:cNvSpPr/>
          <p:nvPr/>
        </p:nvSpPr>
        <p:spPr>
          <a:xfrm>
            <a:off x="4001491" y="5297868"/>
            <a:ext cx="785753" cy="297004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F95661C-2563-44EC-8E71-D08C07A0B3DF}"/>
              </a:ext>
            </a:extLst>
          </p:cNvPr>
          <p:cNvSpPr txBox="1"/>
          <p:nvPr/>
        </p:nvSpPr>
        <p:spPr>
          <a:xfrm>
            <a:off x="2058185" y="998208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1</a:t>
            </a:r>
            <a:endParaRPr lang="zh-CN" altLang="en-US" sz="11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2A026D9-C919-4CCD-B6A6-7A4853894D9B}"/>
              </a:ext>
            </a:extLst>
          </p:cNvPr>
          <p:cNvSpPr txBox="1"/>
          <p:nvPr/>
        </p:nvSpPr>
        <p:spPr>
          <a:xfrm>
            <a:off x="4950791" y="985703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1</a:t>
            </a:r>
            <a:endParaRPr lang="zh-CN" altLang="en-US" sz="11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5AC16A7-9CC4-4A39-AA7C-B5FD18A7FED7}"/>
              </a:ext>
            </a:extLst>
          </p:cNvPr>
          <p:cNvSpPr txBox="1"/>
          <p:nvPr/>
        </p:nvSpPr>
        <p:spPr>
          <a:xfrm>
            <a:off x="2058184" y="3015556"/>
            <a:ext cx="6912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3a</a:t>
            </a:r>
            <a:endParaRPr lang="zh-CN" altLang="en-US" sz="11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F40BD43-F8DD-4A74-A6A9-0064AA47B92F}"/>
              </a:ext>
            </a:extLst>
          </p:cNvPr>
          <p:cNvSpPr txBox="1"/>
          <p:nvPr/>
        </p:nvSpPr>
        <p:spPr>
          <a:xfrm>
            <a:off x="4950791" y="3003051"/>
            <a:ext cx="6912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DNMT3a</a:t>
            </a:r>
            <a:endParaRPr lang="zh-CN" altLang="en-US" sz="11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5A9DD9B-F1A5-4ED9-851C-BBC881E50AF1}"/>
              </a:ext>
            </a:extLst>
          </p:cNvPr>
          <p:cNvSpPr txBox="1"/>
          <p:nvPr/>
        </p:nvSpPr>
        <p:spPr>
          <a:xfrm>
            <a:off x="2058184" y="4848287"/>
            <a:ext cx="5822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β-actin</a:t>
            </a:r>
            <a:endParaRPr lang="zh-CN" altLang="en-US" sz="11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0B77EB1-16C0-417E-9995-9586FFAB7CFF}"/>
              </a:ext>
            </a:extLst>
          </p:cNvPr>
          <p:cNvSpPr txBox="1"/>
          <p:nvPr/>
        </p:nvSpPr>
        <p:spPr>
          <a:xfrm>
            <a:off x="4942254" y="4835782"/>
            <a:ext cx="5822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β-actin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42332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BFD4BC1-DCE6-4BB2-951A-F26B8C4CE5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8349" y="1056447"/>
            <a:ext cx="2638425" cy="92614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9C601C9-1E00-44A8-A440-7C82A1F06A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8349" y="4266900"/>
            <a:ext cx="2440907" cy="89846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64B85B5-58F4-4248-AFA9-8BECF21BB287}"/>
              </a:ext>
            </a:extLst>
          </p:cNvPr>
          <p:cNvSpPr txBox="1"/>
          <p:nvPr/>
        </p:nvSpPr>
        <p:spPr>
          <a:xfrm>
            <a:off x="1437667" y="149776"/>
            <a:ext cx="1831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NMT3a CO-IP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35144FC-6AC9-44FE-BA86-F33475AA5B1C}"/>
              </a:ext>
            </a:extLst>
          </p:cNvPr>
          <p:cNvSpPr txBox="1"/>
          <p:nvPr/>
        </p:nvSpPr>
        <p:spPr>
          <a:xfrm>
            <a:off x="1350189" y="723410"/>
            <a:ext cx="478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put</a:t>
            </a:r>
            <a:endParaRPr lang="zh-CN" altLang="en-US" sz="10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026F19C-0AC3-4C98-A8AA-BB7DEDAFE4CD}"/>
              </a:ext>
            </a:extLst>
          </p:cNvPr>
          <p:cNvSpPr txBox="1"/>
          <p:nvPr/>
        </p:nvSpPr>
        <p:spPr>
          <a:xfrm>
            <a:off x="1730511" y="723410"/>
            <a:ext cx="397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gG</a:t>
            </a:r>
            <a:endParaRPr lang="zh-CN" altLang="en-US" sz="10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4B3AEFD-ED60-4707-80FD-544621A072E4}"/>
              </a:ext>
            </a:extLst>
          </p:cNvPr>
          <p:cNvSpPr txBox="1"/>
          <p:nvPr/>
        </p:nvSpPr>
        <p:spPr>
          <a:xfrm>
            <a:off x="2029833" y="723410"/>
            <a:ext cx="4782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nti-</a:t>
            </a:r>
          </a:p>
          <a:p>
            <a:r>
              <a:rPr lang="en-US" altLang="zh-CN" sz="1000" dirty="0"/>
              <a:t>GLI1</a:t>
            </a:r>
            <a:endParaRPr lang="zh-CN" altLang="en-US" sz="10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F972C5B-FCD2-48C4-A33D-30DD9F180715}"/>
              </a:ext>
            </a:extLst>
          </p:cNvPr>
          <p:cNvSpPr txBox="1"/>
          <p:nvPr/>
        </p:nvSpPr>
        <p:spPr>
          <a:xfrm>
            <a:off x="2390091" y="723410"/>
            <a:ext cx="478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put</a:t>
            </a:r>
            <a:endParaRPr lang="zh-CN" altLang="en-US" sz="10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ACAEA4-ACCD-4ED0-B084-EB4606ED911F}"/>
              </a:ext>
            </a:extLst>
          </p:cNvPr>
          <p:cNvSpPr txBox="1"/>
          <p:nvPr/>
        </p:nvSpPr>
        <p:spPr>
          <a:xfrm>
            <a:off x="2720778" y="721365"/>
            <a:ext cx="478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put</a:t>
            </a:r>
            <a:endParaRPr lang="zh-CN" altLang="en-US" sz="10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4169B9F-4538-4C1B-9A54-FEE400664431}"/>
              </a:ext>
            </a:extLst>
          </p:cNvPr>
          <p:cNvSpPr txBox="1"/>
          <p:nvPr/>
        </p:nvSpPr>
        <p:spPr>
          <a:xfrm>
            <a:off x="1731598" y="3897568"/>
            <a:ext cx="1116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305A408-4D84-4C6D-9DDC-1A346AA11D32}"/>
              </a:ext>
            </a:extLst>
          </p:cNvPr>
          <p:cNvSpPr txBox="1"/>
          <p:nvPr/>
        </p:nvSpPr>
        <p:spPr>
          <a:xfrm>
            <a:off x="4220916" y="149776"/>
            <a:ext cx="1831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NMT1 CO-IP</a:t>
            </a:r>
            <a:endParaRPr lang="zh-CN" altLang="en-US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06EC9CAB-4417-444A-805C-DCA6BB09D7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10101" y="4268140"/>
            <a:ext cx="1569460" cy="835224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BBA3A2E4-4304-4D95-8421-6590063769E9}"/>
              </a:ext>
            </a:extLst>
          </p:cNvPr>
          <p:cNvSpPr txBox="1"/>
          <p:nvPr/>
        </p:nvSpPr>
        <p:spPr>
          <a:xfrm>
            <a:off x="4567075" y="3947088"/>
            <a:ext cx="10606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β-actin</a:t>
            </a:r>
            <a:endParaRPr lang="zh-CN" altLang="en-US" sz="1400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A7BBFCB4-76F4-4291-8259-34643950ECD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64925" y="1050592"/>
            <a:ext cx="1681649" cy="869307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6517F730-D4E8-499D-9A18-AF7A119407D7}"/>
              </a:ext>
            </a:extLst>
          </p:cNvPr>
          <p:cNvSpPr txBox="1"/>
          <p:nvPr/>
        </p:nvSpPr>
        <p:spPr>
          <a:xfrm>
            <a:off x="4499789" y="723410"/>
            <a:ext cx="478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put</a:t>
            </a:r>
            <a:endParaRPr lang="zh-CN" altLang="en-US" sz="10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52112AE-CA4E-49A1-B2A8-518A38E9A11B}"/>
              </a:ext>
            </a:extLst>
          </p:cNvPr>
          <p:cNvSpPr txBox="1"/>
          <p:nvPr/>
        </p:nvSpPr>
        <p:spPr>
          <a:xfrm>
            <a:off x="4880111" y="723410"/>
            <a:ext cx="397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gG</a:t>
            </a:r>
            <a:endParaRPr lang="zh-CN" altLang="en-US" sz="10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27C1892-77B1-4377-BAAC-740E5079969B}"/>
              </a:ext>
            </a:extLst>
          </p:cNvPr>
          <p:cNvSpPr txBox="1"/>
          <p:nvPr/>
        </p:nvSpPr>
        <p:spPr>
          <a:xfrm>
            <a:off x="5179433" y="723410"/>
            <a:ext cx="4782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Anti-</a:t>
            </a:r>
          </a:p>
          <a:p>
            <a:r>
              <a:rPr lang="en-US" altLang="zh-CN" sz="1000" dirty="0"/>
              <a:t>GLI1</a:t>
            </a:r>
            <a:endParaRPr lang="zh-CN" altLang="en-US" sz="1000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70D64631-7F8B-4796-995C-CC1D25B16BB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" contrast="20000"/>
                    </a14:imgEffect>
                  </a14:imgLayer>
                </a14:imgProps>
              </a:ext>
            </a:extLst>
          </a:blip>
          <a:srcRect l="11857" t="23130" r="10262" b="17365"/>
          <a:stretch/>
        </p:blipFill>
        <p:spPr>
          <a:xfrm>
            <a:off x="982829" y="2236921"/>
            <a:ext cx="2440907" cy="1406314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81B14A50-873E-438E-81D4-6EF995DF075E}"/>
              </a:ext>
            </a:extLst>
          </p:cNvPr>
          <p:cNvSpPr/>
          <p:nvPr/>
        </p:nvSpPr>
        <p:spPr>
          <a:xfrm>
            <a:off x="1400989" y="1450743"/>
            <a:ext cx="1039902" cy="287437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6AA4CA65-F6C2-43DD-85B3-33705A598B95}"/>
              </a:ext>
            </a:extLst>
          </p:cNvPr>
          <p:cNvSpPr/>
          <p:nvPr/>
        </p:nvSpPr>
        <p:spPr>
          <a:xfrm>
            <a:off x="1578132" y="2960675"/>
            <a:ext cx="939020" cy="273082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73A6C11-8A9C-46A3-9914-F361C441947E}"/>
              </a:ext>
            </a:extLst>
          </p:cNvPr>
          <p:cNvSpPr/>
          <p:nvPr/>
        </p:nvSpPr>
        <p:spPr>
          <a:xfrm>
            <a:off x="4523773" y="1165725"/>
            <a:ext cx="1043907" cy="27699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1EB286C4-AE0C-4453-B9CB-068DBF7E213B}"/>
              </a:ext>
            </a:extLst>
          </p:cNvPr>
          <p:cNvSpPr/>
          <p:nvPr/>
        </p:nvSpPr>
        <p:spPr>
          <a:xfrm>
            <a:off x="4499789" y="4802732"/>
            <a:ext cx="1157855" cy="300632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E5682AF1-28CD-44EE-AF1F-9C4DAB036C67}"/>
              </a:ext>
            </a:extLst>
          </p:cNvPr>
          <p:cNvSpPr/>
          <p:nvPr/>
        </p:nvSpPr>
        <p:spPr>
          <a:xfrm>
            <a:off x="1273823" y="4859991"/>
            <a:ext cx="1058499" cy="309952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8CD30208-4006-4929-A800-9A8E14F0BC8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0553" t="20553" r="20553" b="20553"/>
          <a:stretch/>
        </p:blipFill>
        <p:spPr>
          <a:xfrm>
            <a:off x="4125374" y="2236921"/>
            <a:ext cx="1927153" cy="1339548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4CC84837-E37C-4C2F-87D3-C7E187CDCCB3}"/>
              </a:ext>
            </a:extLst>
          </p:cNvPr>
          <p:cNvSpPr/>
          <p:nvPr/>
        </p:nvSpPr>
        <p:spPr>
          <a:xfrm>
            <a:off x="4481656" y="2521425"/>
            <a:ext cx="1143092" cy="299398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F30952D-382A-48A6-9734-B4A9CAC33719}"/>
              </a:ext>
            </a:extLst>
          </p:cNvPr>
          <p:cNvSpPr txBox="1"/>
          <p:nvPr/>
        </p:nvSpPr>
        <p:spPr>
          <a:xfrm>
            <a:off x="1891176" y="2289587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GLI1</a:t>
            </a:r>
            <a:endParaRPr lang="zh-CN" altLang="en-US" sz="11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9D508E4-B007-42B9-ACF4-9895C9D230D2}"/>
              </a:ext>
            </a:extLst>
          </p:cNvPr>
          <p:cNvSpPr txBox="1"/>
          <p:nvPr/>
        </p:nvSpPr>
        <p:spPr>
          <a:xfrm>
            <a:off x="4836176" y="2150806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/>
              <a:t>GLI1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78699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自定义</PresentationFormat>
  <Paragraphs>26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aoran Ge</dc:creator>
  <cp:lastModifiedBy>Gaoran Ge</cp:lastModifiedBy>
  <cp:revision>2</cp:revision>
  <dcterms:created xsi:type="dcterms:W3CDTF">2023-10-12T06:24:42Z</dcterms:created>
  <dcterms:modified xsi:type="dcterms:W3CDTF">2023-10-12T06:26:24Z</dcterms:modified>
</cp:coreProperties>
</file>